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  <p:ext uri="{2D200454-40CA-4A62-9FC3-DE9A4176ACB9}">
      <p15:notes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eman, Zachary" initials="FZ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FF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13" autoAdjust="0"/>
    <p:restoredTop sz="69903" autoAdjust="0"/>
  </p:normalViewPr>
  <p:slideViewPr>
    <p:cSldViewPr snapToGrid="0">
      <p:cViewPr>
        <p:scale>
          <a:sx n="160" d="100"/>
          <a:sy n="160" d="100"/>
        </p:scale>
        <p:origin x="-252" y="34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3" d="100"/>
          <a:sy n="73" d="100"/>
        </p:scale>
        <p:origin x="22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674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DBD3558C-0035-48B5-AB58-788A86F55A4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674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777CC2A-ED66-41CA-8D7C-0DED167903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290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4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58E5CAB3-8DA8-4612-9FB4-C043D70D76FF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1" rIns="93279" bIns="4664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7"/>
            <a:ext cx="5615940" cy="3664209"/>
          </a:xfrm>
          <a:prstGeom prst="rect">
            <a:avLst/>
          </a:prstGeom>
        </p:spPr>
        <p:txBody>
          <a:bodyPr vert="horz" lIns="93279" tIns="46641" rIns="93279" bIns="46641" rtlCol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4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9F49ED3-0D8E-400C-AB96-46AED9631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864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6050" y="1163638"/>
            <a:ext cx="4187825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istograms of PD-L1 expression in PC3 cells treated with RVX208 and/or IFN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γ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MFI as indicated. N=1/iteration, repeated x 1. </a:t>
            </a:r>
          </a:p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mmary flow cytometry data for A. N=1/iteration, repeated x 1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49ED3-0D8E-400C-AB96-46AED96312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8670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56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114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970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95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01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29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5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350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31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02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60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589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4019740"/>
              </p:ext>
            </p:extLst>
          </p:nvPr>
        </p:nvGraphicFramePr>
        <p:xfrm>
          <a:off x="5060524" y="1721696"/>
          <a:ext cx="2719041" cy="3221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25" name="Prism 6" r:id="rId4" imgW="3451541" imgH="4089189" progId="Prism6.Document">
                  <p:embed/>
                </p:oleObj>
              </mc:Choice>
              <mc:Fallback>
                <p:oleObj name="Prism 6" r:id="rId4" imgW="3451541" imgH="408918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60524" y="1721696"/>
                        <a:ext cx="2719041" cy="3221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5139047" y="3418959"/>
            <a:ext cx="2683616" cy="1327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546065" y="3477833"/>
            <a:ext cx="2276598" cy="538074"/>
            <a:chOff x="3885781" y="1939809"/>
            <a:chExt cx="831003" cy="823166"/>
          </a:xfrm>
          <a:solidFill>
            <a:schemeClr val="bg1"/>
          </a:solidFill>
        </p:grpSpPr>
        <p:sp>
          <p:nvSpPr>
            <p:cNvPr id="7" name="TextBox 6"/>
            <p:cNvSpPr txBox="1"/>
            <p:nvPr/>
          </p:nvSpPr>
          <p:spPr>
            <a:xfrm>
              <a:off x="3886810" y="1939809"/>
              <a:ext cx="829974" cy="4590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-     +     +     +    +    -     -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885781" y="2303898"/>
              <a:ext cx="831003" cy="4590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-     -   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0.5µM   5µM  50µM 5µM  50µM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7779565" y="3463192"/>
            <a:ext cx="751763" cy="528351"/>
            <a:chOff x="3886812" y="2010106"/>
            <a:chExt cx="687607" cy="822399"/>
          </a:xfrm>
          <a:solidFill>
            <a:schemeClr val="bg1"/>
          </a:solidFill>
        </p:grpSpPr>
        <p:sp>
          <p:nvSpPr>
            <p:cNvPr id="10" name="TextBox 9"/>
            <p:cNvSpPr txBox="1"/>
            <p:nvPr/>
          </p:nvSpPr>
          <p:spPr>
            <a:xfrm>
              <a:off x="3886812" y="2010106"/>
              <a:ext cx="597968" cy="39523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886812" y="2437275"/>
              <a:ext cx="687607" cy="39523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RVX-208</a:t>
              </a:r>
            </a:p>
          </p:txBody>
        </p:sp>
      </p:grpSp>
      <p:cxnSp>
        <p:nvCxnSpPr>
          <p:cNvPr id="14" name="Straight Connector 13"/>
          <p:cNvCxnSpPr/>
          <p:nvPr/>
        </p:nvCxnSpPr>
        <p:spPr>
          <a:xfrm>
            <a:off x="8497056" y="3545517"/>
            <a:ext cx="0" cy="34737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5400000">
            <a:off x="8397154" y="3553601"/>
            <a:ext cx="35536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10973" y="1127008"/>
            <a:ext cx="64437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098508" y="1249796"/>
            <a:ext cx="64437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6">
            <a:biLevel thresh="75000"/>
          </a:blip>
          <a:stretch>
            <a:fillRect/>
          </a:stretch>
        </p:blipFill>
        <p:spPr>
          <a:xfrm>
            <a:off x="477302" y="1574051"/>
            <a:ext cx="3045647" cy="2702931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246322" y="4515950"/>
            <a:ext cx="186580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D-L1 expression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BV421 fluorescence)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54583" y="2681417"/>
            <a:ext cx="1361996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lative cell number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096938" y="4352390"/>
            <a:ext cx="2006203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17980" y="1673985"/>
            <a:ext cx="653760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204908" y="1922319"/>
            <a:ext cx="1855616" cy="22031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y</a:t>
            </a:r>
          </a:p>
          <a:p>
            <a:pPr>
              <a:lnSpc>
                <a:spcPts val="111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5µM RVX208 + IFN-y</a:t>
            </a:r>
          </a:p>
          <a:p>
            <a:pPr>
              <a:lnSpc>
                <a:spcPts val="111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µM RVX208 + IFN-y</a:t>
            </a:r>
          </a:p>
          <a:p>
            <a:pPr>
              <a:lnSpc>
                <a:spcPts val="111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µM RVX208 +IFN-y </a:t>
            </a:r>
          </a:p>
          <a:p>
            <a:pPr>
              <a:lnSpc>
                <a:spcPts val="111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µM RVX208</a:t>
            </a:r>
          </a:p>
          <a:p>
            <a:pPr>
              <a:lnSpc>
                <a:spcPts val="111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µM RVX208</a:t>
            </a:r>
          </a:p>
          <a:p>
            <a:pPr>
              <a:lnSpc>
                <a:spcPts val="111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11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17979" y="2053317"/>
            <a:ext cx="1855616" cy="2349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21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998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634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32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84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28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32</a:t>
            </a: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50"/>
              </a:lnSpc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-25478" y="6573731"/>
            <a:ext cx="397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o et. al. </a:t>
            </a:r>
          </a:p>
        </p:txBody>
      </p:sp>
    </p:spTree>
    <p:extLst>
      <p:ext uri="{BB962C8B-B14F-4D97-AF65-F5344CB8AC3E}">
        <p14:creationId xmlns:p14="http://schemas.microsoft.com/office/powerpoint/2010/main" val="515224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15</TotalTime>
  <Words>111</Words>
  <Application>Microsoft Office PowerPoint</Application>
  <PresentationFormat>On-screen Show (4:3)</PresentationFormat>
  <Paragraphs>43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Columbi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Figures</dc:title>
  <dc:creator>Mao, Wendy</dc:creator>
  <cp:lastModifiedBy>USER</cp:lastModifiedBy>
  <cp:revision>253</cp:revision>
  <cp:lastPrinted>2019-02-04T21:11:13Z</cp:lastPrinted>
  <dcterms:created xsi:type="dcterms:W3CDTF">2018-06-19T14:49:33Z</dcterms:created>
  <dcterms:modified xsi:type="dcterms:W3CDTF">2019-10-08T02:57:17Z</dcterms:modified>
</cp:coreProperties>
</file>